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</p:sldIdLst>
  <p:sldSz cx="9601200" cy="12801600" type="A3"/>
  <p:notesSz cx="6761163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48" autoAdjust="0"/>
    <p:restoredTop sz="94660"/>
  </p:normalViewPr>
  <p:slideViewPr>
    <p:cSldViewPr snapToGrid="0">
      <p:cViewPr varScale="1">
        <p:scale>
          <a:sx n="55" d="100"/>
          <a:sy n="55" d="100"/>
        </p:scale>
        <p:origin x="34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5588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6027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6746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94807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98204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9294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2749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127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130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66248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4386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CCBD4-AD46-4562-90E5-6817BDCDD30C}" type="datetimeFigureOut">
              <a:rPr lang="en-IN" smtClean="0"/>
              <a:t>03-01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A04EF-A590-45E3-A9C9-8F9AC1A6074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7221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theses.hal.science/tel-04967869/file/TRANVANCANH.pdf" TargetMode="External"/><Relationship Id="rId2" Type="http://schemas.openxmlformats.org/officeDocument/2006/relationships/hyperlink" Target="https://conekt.sbs.ntu.edu.sg/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E28EE9-B794-52D9-3516-01980B9C1C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id="{1847A188-2FD3-18C1-960F-9AD99C60C16E}"/>
              </a:ext>
            </a:extLst>
          </p:cNvPr>
          <p:cNvGrpSpPr/>
          <p:nvPr/>
        </p:nvGrpSpPr>
        <p:grpSpPr>
          <a:xfrm>
            <a:off x="1690688" y="1155866"/>
            <a:ext cx="6219825" cy="10489868"/>
            <a:chOff x="1284287" y="458589"/>
            <a:chExt cx="6219825" cy="10489868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5841EFB1-6F3C-3256-6469-6FD015BB04C0}"/>
                </a:ext>
              </a:extLst>
            </p:cNvPr>
            <p:cNvGrpSpPr/>
            <p:nvPr/>
          </p:nvGrpSpPr>
          <p:grpSpPr>
            <a:xfrm>
              <a:off x="2245901" y="458589"/>
              <a:ext cx="2673177" cy="504155"/>
              <a:chOff x="2466031" y="238460"/>
              <a:chExt cx="2673177" cy="504155"/>
            </a:xfrm>
          </p:grpSpPr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333B0BF2-680D-EFC7-1882-EADF43E1A1A4}"/>
                  </a:ext>
                </a:extLst>
              </p:cNvPr>
              <p:cNvSpPr/>
              <p:nvPr/>
            </p:nvSpPr>
            <p:spPr>
              <a:xfrm>
                <a:off x="2599209" y="238460"/>
                <a:ext cx="2304000" cy="216000"/>
              </a:xfrm>
              <a:prstGeom prst="rect">
                <a:avLst/>
              </a:prstGeom>
              <a:gradFill>
                <a:gsLst>
                  <a:gs pos="0">
                    <a:srgbClr val="FFFFFF"/>
                  </a:gs>
                  <a:gs pos="50000">
                    <a:srgbClr val="7F7FFF"/>
                  </a:gs>
                  <a:gs pos="100000">
                    <a:srgbClr val="0000FF"/>
                  </a:gs>
                </a:gsLst>
                <a:lin ang="206018" scaled="1"/>
              </a:gradFill>
              <a:ln w="5080">
                <a:solidFill>
                  <a:srgbClr val="40808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60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71C8439-4ACF-E1B4-AF5F-5825F181C906}"/>
                  </a:ext>
                </a:extLst>
              </p:cNvPr>
              <p:cNvSpPr txBox="1"/>
              <p:nvPr/>
            </p:nvSpPr>
            <p:spPr>
              <a:xfrm>
                <a:off x="2787003" y="404061"/>
                <a:ext cx="199445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  <a:endParaRPr lang="en-I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C196B5D-4C53-8D03-159B-EAF672FD24CD}"/>
                  </a:ext>
                </a:extLst>
              </p:cNvPr>
              <p:cNvSpPr txBox="1"/>
              <p:nvPr/>
            </p:nvSpPr>
            <p:spPr>
              <a:xfrm>
                <a:off x="2466031" y="404061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I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80892A28-F2DD-2F0F-2309-D101A2441348}"/>
                  </a:ext>
                </a:extLst>
              </p:cNvPr>
              <p:cNvSpPr txBox="1"/>
              <p:nvPr/>
            </p:nvSpPr>
            <p:spPr>
              <a:xfrm>
                <a:off x="4669208" y="404061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IN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B8D0D496-9FC0-1DBF-7D2D-8A0A6773D125}"/>
                </a:ext>
              </a:extLst>
            </p:cNvPr>
            <p:cNvGrpSpPr/>
            <p:nvPr/>
          </p:nvGrpSpPr>
          <p:grpSpPr>
            <a:xfrm>
              <a:off x="1284287" y="908216"/>
              <a:ext cx="6219825" cy="10040241"/>
              <a:chOff x="1284287" y="908216"/>
              <a:chExt cx="6219825" cy="10040241"/>
            </a:xfrm>
          </p:grpSpPr>
          <p:pic>
            <p:nvPicPr>
              <p:cNvPr id="3" name="Graphic 2">
                <a:extLst>
                  <a:ext uri="{FF2B5EF4-FFF2-40B4-BE49-F238E27FC236}">
                    <a16:creationId xmlns:a16="http://schemas.microsoft.com/office/drawing/2014/main" id="{886A48A8-69B8-608B-2F67-FB9BAC7335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rcRect t="4334"/>
              <a:stretch>
                <a:fillRect/>
              </a:stretch>
            </p:blipFill>
            <p:spPr>
              <a:xfrm>
                <a:off x="1284287" y="1307804"/>
                <a:ext cx="6219825" cy="9640653"/>
              </a:xfrm>
              <a:prstGeom prst="rect">
                <a:avLst/>
              </a:prstGeom>
            </p:spPr>
          </p:pic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17D512C0-E36F-862C-6BB9-3D25F90CBA5C}"/>
                  </a:ext>
                </a:extLst>
              </p:cNvPr>
              <p:cNvGrpSpPr/>
              <p:nvPr/>
            </p:nvGrpSpPr>
            <p:grpSpPr>
              <a:xfrm>
                <a:off x="1416886" y="908216"/>
                <a:ext cx="4059373" cy="358169"/>
                <a:chOff x="1547771" y="1908073"/>
                <a:chExt cx="3485163" cy="358169"/>
              </a:xfrm>
            </p:grpSpPr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E7AE1BB4-034C-05BB-9F32-3B14AA12FC46}"/>
                    </a:ext>
                  </a:extLst>
                </p:cNvPr>
                <p:cNvSpPr txBox="1"/>
                <p:nvPr/>
              </p:nvSpPr>
              <p:spPr>
                <a:xfrm>
                  <a:off x="2162680" y="1908073"/>
                  <a:ext cx="104200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GF</a:t>
                  </a:r>
                  <a:endParaRPr lang="en-IN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Right Bracket 28">
                  <a:extLst>
                    <a:ext uri="{FF2B5EF4-FFF2-40B4-BE49-F238E27FC236}">
                      <a16:creationId xmlns:a16="http://schemas.microsoft.com/office/drawing/2014/main" id="{2B488895-725D-B76C-B123-DFC7D22CC774}"/>
                    </a:ext>
                  </a:extLst>
                </p:cNvPr>
                <p:cNvSpPr/>
                <p:nvPr/>
              </p:nvSpPr>
              <p:spPr>
                <a:xfrm rot="16200000">
                  <a:off x="2670810" y="1071203"/>
                  <a:ext cx="72000" cy="2318077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32" name="Right Bracket 31">
                  <a:extLst>
                    <a:ext uri="{FF2B5EF4-FFF2-40B4-BE49-F238E27FC236}">
                      <a16:creationId xmlns:a16="http://schemas.microsoft.com/office/drawing/2014/main" id="{76458669-4E82-63BE-2038-D49B9D903F12}"/>
                    </a:ext>
                  </a:extLst>
                </p:cNvPr>
                <p:cNvSpPr/>
                <p:nvPr/>
              </p:nvSpPr>
              <p:spPr>
                <a:xfrm rot="16200000">
                  <a:off x="4456050" y="1689356"/>
                  <a:ext cx="72000" cy="1081769"/>
                </a:xfrm>
                <a:prstGeom prst="rightBracket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3453DBAD-D2CD-277E-89BB-7EA87AFC8B60}"/>
                    </a:ext>
                  </a:extLst>
                </p:cNvPr>
                <p:cNvSpPr txBox="1"/>
                <p:nvPr/>
              </p:nvSpPr>
              <p:spPr>
                <a:xfrm>
                  <a:off x="3956123" y="1908073"/>
                  <a:ext cx="104200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GF-RK</a:t>
                  </a:r>
                  <a:endParaRPr lang="en-IN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903978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51A4B15-C4EA-8DB3-8BF8-3075A8A87008}"/>
              </a:ext>
            </a:extLst>
          </p:cNvPr>
          <p:cNvSpPr txBox="1"/>
          <p:nvPr/>
        </p:nvSpPr>
        <p:spPr>
          <a:xfrm>
            <a:off x="660400" y="2845387"/>
            <a:ext cx="828040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kumimoji="0" 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10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issue-specific expression profile of root growth factor (RGF) and RGF-receptor kinase (RGF-RK) genes in tomato. The heatmap displays the relative expression level of each gene across various tissues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e that tomato RGF Solyc04g005240 is exclusively expressed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the root meristematic zone. Mean expression data were sourced from the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nek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latform (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hlinkClick r:id="rId2"/>
              </a:rPr>
              <a:t>https://conekt.sbs.ntu.edu.sg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. No expression was found for RGF (Solyc07g021340)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RGF-RK (Solyc00g009090)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n the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Nek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ite. Expression values for each gene were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ormalised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to their maximum expression level observed in any tissue (set to 1). The accompanying color scale bar indicates the relative expression intensity. For the relative values for each gene, see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ataset S7. 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ote: The tomato root growth factors (RGF) and RGF receptor kinase are arranged as per the dendrogram described by Fang et al. (2021) [(See Fang Y, Chang J, Shi T, Luo W, Ou Y, Wan D, Li J. Evolution of RGF/GLV/CLEL peptide hormones and their roles in land plant growth and regulation. International Journal of Molecular Sciences. 2021 Dec 13;22(24):13372. See Figure 2 for RGF and Figure 6 for RGF-RK in the above paper]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 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wo	additional tomato RGFs (Solyc03g093075 and Solc05g011825) were identified by </a:t>
            </a:r>
            <a:r>
              <a:rPr lang="fr-FR" sz="1200" dirty="0"/>
              <a:t>Van </a:t>
            </a:r>
            <a:r>
              <a:rPr lang="fr-FR" sz="1200" dirty="0" err="1"/>
              <a:t>Canh</a:t>
            </a:r>
            <a:r>
              <a:rPr lang="fr-FR" sz="1200" dirty="0"/>
              <a:t> LT. (2024) are </a:t>
            </a:r>
            <a:r>
              <a:rPr lang="fr-FR" sz="1200" dirty="0" err="1"/>
              <a:t>also</a:t>
            </a:r>
            <a:r>
              <a:rPr lang="fr-FR" sz="1200" dirty="0"/>
              <a:t> </a:t>
            </a:r>
            <a:r>
              <a:rPr lang="fr-FR" sz="1200" dirty="0" err="1"/>
              <a:t>included</a:t>
            </a:r>
            <a:r>
              <a:rPr lang="fr-FR" sz="1200" dirty="0"/>
              <a:t> in </a:t>
            </a:r>
            <a:r>
              <a:rPr lang="fr-FR" sz="1200" dirty="0" err="1"/>
              <a:t>heat</a:t>
            </a:r>
            <a:r>
              <a:rPr lang="fr-FR" sz="1200" dirty="0"/>
              <a:t> </a:t>
            </a:r>
            <a:r>
              <a:rPr lang="fr-FR" sz="1200" dirty="0" err="1"/>
              <a:t>map</a:t>
            </a:r>
            <a:r>
              <a:rPr lang="fr-FR" sz="1200" dirty="0"/>
              <a:t> (</a:t>
            </a:r>
            <a:r>
              <a:rPr lang="fr-FR" sz="1200" dirty="0" err="1"/>
              <a:t>See</a:t>
            </a:r>
            <a:r>
              <a:rPr lang="fr-FR" sz="1200" dirty="0"/>
              <a:t> Van </a:t>
            </a:r>
            <a:r>
              <a:rPr lang="fr-FR" sz="1200" dirty="0" err="1"/>
              <a:t>Canh</a:t>
            </a:r>
            <a:r>
              <a:rPr lang="fr-FR" sz="1200" dirty="0"/>
              <a:t> LT. (2024) </a:t>
            </a:r>
            <a:r>
              <a:rPr lang="fr-FR" sz="1200" i="1" dirty="0"/>
              <a:t>Exploration des petits peptides sécrétés par les plantes en réponse aux stress: vers de nouvelles solutions de biocontrôle</a:t>
            </a:r>
            <a:r>
              <a:rPr lang="fr-FR" sz="1200" dirty="0"/>
              <a:t> (Doctoral dissertation, Université d'Angers </a:t>
            </a:r>
            <a:r>
              <a:rPr lang="fr-FR" sz="1200" dirty="0">
                <a:hlinkClick r:id="rId3"/>
              </a:rPr>
              <a:t>https://theses.hal.science/tel-04967869/file/TRANVANCANH.pdf</a:t>
            </a:r>
            <a:r>
              <a:rPr lang="fr-FR" sz="1200" dirty="0"/>
              <a:t>)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	</a:t>
            </a:r>
          </a:p>
          <a:p>
            <a:pPr lvl="0" algn="just"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lvl="0" algn="just">
              <a:defRPr/>
            </a:pP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6243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37</TotalTime>
  <Words>317</Words>
  <Application>Microsoft Office PowerPoint</Application>
  <PresentationFormat>A3 Paper (297x420 mm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meshwar Sharma</dc:creator>
  <cp:lastModifiedBy>Rameshwar Sharma</cp:lastModifiedBy>
  <cp:revision>23</cp:revision>
  <cp:lastPrinted>2025-10-17T09:09:59Z</cp:lastPrinted>
  <dcterms:created xsi:type="dcterms:W3CDTF">2025-10-15T06:40:21Z</dcterms:created>
  <dcterms:modified xsi:type="dcterms:W3CDTF">2026-01-03T09:04:10Z</dcterms:modified>
</cp:coreProperties>
</file>